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5" autoAdjust="0"/>
    <p:restoredTop sz="94660"/>
  </p:normalViewPr>
  <p:slideViewPr>
    <p:cSldViewPr snapToGrid="0">
      <p:cViewPr varScale="1">
        <p:scale>
          <a:sx n="88" d="100"/>
          <a:sy n="88" d="100"/>
        </p:scale>
        <p:origin x="10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D60E36-6853-BD59-095A-B798354D82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E4D639-A041-4326-7824-1F950153B2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D83BF9-05BF-AA3B-FEB3-B0E10661E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D5F3D2-49A7-6ADD-31BD-99586FE06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4971B0-C48A-3680-35BC-4C8F7AB2D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95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E95D03-E23C-BC84-43E0-FF0052904F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41F5A9-ABFC-B5ED-C16F-C0259455B2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F976D3-4E07-B583-0441-8CC76D6F7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63B5F-5578-3AA7-011F-640159A9A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DA0907-C34A-1DCB-56BC-D2A00FB9D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753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52789E-BD3A-92B4-1B14-42F1CF9F34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0E03BC-EEE3-5F88-C3CF-4EAA863093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BD8007-86B1-A708-1BFB-EC4CBA705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491C80-1A93-AAEF-3DCD-C4D2767BD3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914F9C-42A1-D361-8642-578FCAE28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223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C1A033-A0A3-8571-AE12-9DC8634975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398115-3079-E20D-5A4B-BB39E78091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566A93-081C-2281-41E6-14F72AF8A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367213-6AE7-7535-2486-64047E498E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0970AC-4BFF-7895-46FE-047D5E772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440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C29D86-10FD-C483-BD77-1BA8166195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645475-6379-ABC6-CE2C-078162FDD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424F88-E679-BEA1-B26F-E3E2F007D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B855D0-00EE-2AEE-3958-53DD5D58C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3E7C89-B2D8-5721-E8E9-8D6F2D94F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322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089623-AB67-78B9-09B2-F7F5D4811A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FA7C57-56EF-9F09-9606-1875CC654A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4550FF-E760-BBB9-E650-A5BDDEB250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699548-EC29-EA0F-8C9C-734CC86866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E2433A-091A-D1CF-CFF2-F419B6A29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933733-BE4F-5AD0-B02C-930AAD156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841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DE9D4-6B9A-23AF-8E47-898151998E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B23C7E-6E91-4E43-B0B8-F723F0F168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3E52EF-D38B-98A4-10A6-3230BCAB6B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C1E8F3-65FC-0010-1DE8-CE065DCABC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BB58E3-B249-AEA1-D785-321BFD5829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D5200F6-B46D-830C-24C7-9909C7766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F3F92D-31D0-B9BA-B057-FE392A947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30E7E6-D4E6-80C0-F2EF-030866D21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39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C5E417-269E-EC16-CE3F-1ED0C8BEBD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6630635-F2FF-0DD5-3E1E-D8FAF780C5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86A9A0F-036E-221C-AF2F-A0B95DB01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C01154-696A-5247-2F22-1FA9F1A3D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29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0CE4EA-C80F-E15B-8551-01759627B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938EE7-F356-A5E3-1FD7-0F356ACF9E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CA112E-B5B2-EA1A-05FA-94EA39FA2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367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E5B444-9EBD-D7A3-B3C0-106A698451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9FEB19-4023-A2D8-1FC7-0775459586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F9A12E-CB20-CB13-4863-AC3B072049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096C7D-64FF-1DBF-FC08-61EA23E505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77CE45-D71B-7D26-6B50-0493A841A2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CB9A2E-1494-4F43-C61E-94FDDEE78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20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4BE5E-534C-EF6D-3C24-680468133C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EF5010-EF56-8F7F-403E-693294E50C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FC8F9E-B69C-1A76-DB7E-8A85584B74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D51FD2-40B1-7F49-0759-B3DF619EC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4D70E7-0BDE-51E3-1931-EB827096E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BC6E97-84DA-5FB8-B28C-E5D7A0D4E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998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A54E2C-ACE1-602C-640E-D20615BC04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E7E465F-B5FA-071A-7F11-E02DDDFFA9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88EB16-F882-DEB7-8B3F-71A75EA94D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3F3492-EB96-4B99-9FEA-C518ADD8C0BD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31ADF4-381C-5F79-7A86-4473E1C507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8B99A7-A703-995A-E11F-8D9AEE8B50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4FB560-CBE8-423D-8B37-A835DF689D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739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53A8551-EB19-E8B9-7D18-A5D2D0A6B1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4507" y="4845197"/>
            <a:ext cx="6509967" cy="176581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94A86F9-3B88-3EEC-DD99-27CB2CDE03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04507" y="2684458"/>
            <a:ext cx="6509967" cy="180723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A7470FF-C253-5321-119E-146BE180F7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04507" y="444897"/>
            <a:ext cx="6509972" cy="179679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D6A83DC-933C-F232-A83F-AAC650F0587B}"/>
              </a:ext>
            </a:extLst>
          </p:cNvPr>
          <p:cNvSpPr txBox="1"/>
          <p:nvPr/>
        </p:nvSpPr>
        <p:spPr>
          <a:xfrm>
            <a:off x="5871476" y="146226"/>
            <a:ext cx="8732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Quiescent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054D575-7D18-6A56-94D4-162DE77A9321}"/>
              </a:ext>
            </a:extLst>
          </p:cNvPr>
          <p:cNvCxnSpPr>
            <a:cxnSpLocks/>
          </p:cNvCxnSpPr>
          <p:nvPr/>
        </p:nvCxnSpPr>
        <p:spPr>
          <a:xfrm>
            <a:off x="6725367" y="158363"/>
            <a:ext cx="0" cy="6236686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28438347-EAB0-FF55-EBA9-0242B458DD15}"/>
              </a:ext>
            </a:extLst>
          </p:cNvPr>
          <p:cNvSpPr txBox="1"/>
          <p:nvPr/>
        </p:nvSpPr>
        <p:spPr>
          <a:xfrm>
            <a:off x="6753211" y="146226"/>
            <a:ext cx="12261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liferating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21D543BA-CC8D-85C1-581C-2F9C4E0C25CB}"/>
              </a:ext>
            </a:extLst>
          </p:cNvPr>
          <p:cNvCxnSpPr>
            <a:cxnSpLocks/>
          </p:cNvCxnSpPr>
          <p:nvPr/>
        </p:nvCxnSpPr>
        <p:spPr>
          <a:xfrm>
            <a:off x="7671282" y="169538"/>
            <a:ext cx="0" cy="6225511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4624CF72-DBBF-FF44-05CA-285E48B60E17}"/>
              </a:ext>
            </a:extLst>
          </p:cNvPr>
          <p:cNvCxnSpPr>
            <a:cxnSpLocks/>
          </p:cNvCxnSpPr>
          <p:nvPr/>
        </p:nvCxnSpPr>
        <p:spPr>
          <a:xfrm>
            <a:off x="8586490" y="83274"/>
            <a:ext cx="0" cy="6291455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8E67C65-8AE3-509C-CDF0-5DBFC8019C7C}"/>
              </a:ext>
            </a:extLst>
          </p:cNvPr>
          <p:cNvCxnSpPr>
            <a:cxnSpLocks/>
          </p:cNvCxnSpPr>
          <p:nvPr/>
        </p:nvCxnSpPr>
        <p:spPr>
          <a:xfrm>
            <a:off x="9453915" y="162601"/>
            <a:ext cx="0" cy="6232448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5EFFA9A9-796F-ED70-F044-69E76412874B}"/>
              </a:ext>
            </a:extLst>
          </p:cNvPr>
          <p:cNvCxnSpPr>
            <a:cxnSpLocks/>
          </p:cNvCxnSpPr>
          <p:nvPr/>
        </p:nvCxnSpPr>
        <p:spPr>
          <a:xfrm>
            <a:off x="10284477" y="158363"/>
            <a:ext cx="0" cy="6236686"/>
          </a:xfrm>
          <a:prstGeom prst="line">
            <a:avLst/>
          </a:prstGeom>
          <a:ln w="952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791CD23-E6A4-2A31-8940-7211EAF43A4E}"/>
              </a:ext>
            </a:extLst>
          </p:cNvPr>
          <p:cNvSpPr txBox="1"/>
          <p:nvPr/>
        </p:nvSpPr>
        <p:spPr>
          <a:xfrm>
            <a:off x="7799988" y="146226"/>
            <a:ext cx="1020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ans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784BBDC-9B72-D97B-B898-9C4E8521B11D}"/>
              </a:ext>
            </a:extLst>
          </p:cNvPr>
          <p:cNvSpPr txBox="1"/>
          <p:nvPr/>
        </p:nvSpPr>
        <p:spPr>
          <a:xfrm>
            <a:off x="8761547" y="146226"/>
            <a:ext cx="6923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ans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89088DD-A48E-B9A3-DABF-8C759608F60B}"/>
              </a:ext>
            </a:extLst>
          </p:cNvPr>
          <p:cNvSpPr txBox="1"/>
          <p:nvPr/>
        </p:nvSpPr>
        <p:spPr>
          <a:xfrm>
            <a:off x="9484820" y="120358"/>
            <a:ext cx="10209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if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67A6D25-BBA3-F88F-D400-E87AFAA3FA95}"/>
              </a:ext>
            </a:extLst>
          </p:cNvPr>
          <p:cNvSpPr txBox="1"/>
          <p:nvPr/>
        </p:nvSpPr>
        <p:spPr>
          <a:xfrm>
            <a:off x="10321339" y="120358"/>
            <a:ext cx="932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if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2CBB4AA-2845-72C9-5340-A86B80DB15BA}"/>
              </a:ext>
            </a:extLst>
          </p:cNvPr>
          <p:cNvSpPr txBox="1"/>
          <p:nvPr/>
        </p:nvSpPr>
        <p:spPr>
          <a:xfrm>
            <a:off x="-53981" y="471020"/>
            <a:ext cx="564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1A6A7C4-2AC2-3AEB-C152-A99407C8510F}"/>
              </a:ext>
            </a:extLst>
          </p:cNvPr>
          <p:cNvSpPr txBox="1"/>
          <p:nvPr/>
        </p:nvSpPr>
        <p:spPr>
          <a:xfrm>
            <a:off x="3556738" y="145667"/>
            <a:ext cx="564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4803AF8-1487-3970-E30B-1BE798BA1CA4}"/>
              </a:ext>
            </a:extLst>
          </p:cNvPr>
          <p:cNvSpPr txBox="1"/>
          <p:nvPr/>
        </p:nvSpPr>
        <p:spPr>
          <a:xfrm>
            <a:off x="3556738" y="2406696"/>
            <a:ext cx="564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2D54671-6F0F-F176-2E91-214C6E0A6EC6}"/>
              </a:ext>
            </a:extLst>
          </p:cNvPr>
          <p:cNvSpPr txBox="1"/>
          <p:nvPr/>
        </p:nvSpPr>
        <p:spPr>
          <a:xfrm>
            <a:off x="3556738" y="4389913"/>
            <a:ext cx="564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F70983F-B7F0-A93F-DD92-DCCED1CCEF8C}"/>
              </a:ext>
            </a:extLst>
          </p:cNvPr>
          <p:cNvSpPr txBox="1"/>
          <p:nvPr/>
        </p:nvSpPr>
        <p:spPr>
          <a:xfrm>
            <a:off x="-27630" y="3163280"/>
            <a:ext cx="5640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CDFD14E-2FD0-8221-4B43-112D2687F5CD}"/>
              </a:ext>
            </a:extLst>
          </p:cNvPr>
          <p:cNvSpPr txBox="1"/>
          <p:nvPr/>
        </p:nvSpPr>
        <p:spPr>
          <a:xfrm>
            <a:off x="3851627" y="2492023"/>
            <a:ext cx="272974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oE- Remission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Frozen cells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16EF012-6EE7-40BE-3D7F-3D752840BCCF}"/>
              </a:ext>
            </a:extLst>
          </p:cNvPr>
          <p:cNvSpPr txBox="1"/>
          <p:nvPr/>
        </p:nvSpPr>
        <p:spPr>
          <a:xfrm>
            <a:off x="3851627" y="312777"/>
            <a:ext cx="210217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oE- Remission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Fresh cells)</a:t>
            </a:r>
          </a:p>
          <a:p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D4EDB527-9DC4-4CCA-3221-87405EDEA8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4064" y="2980160"/>
            <a:ext cx="1430295" cy="838552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0B6EEFE5-33BA-B54A-D81A-B878303226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90427" y="814822"/>
            <a:ext cx="1358527" cy="821368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3C02CFA4-4B41-0984-2FA1-743FD9088C7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38439" y="5078350"/>
            <a:ext cx="1418370" cy="846833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211CB2ED-0DBE-A8B9-4A40-BC176588ADCA}"/>
              </a:ext>
            </a:extLst>
          </p:cNvPr>
          <p:cNvSpPr txBox="1"/>
          <p:nvPr/>
        </p:nvSpPr>
        <p:spPr>
          <a:xfrm>
            <a:off x="3851627" y="4508449"/>
            <a:ext cx="201109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oE- Remission </a:t>
            </a:r>
          </a:p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Frozen tissue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740D1098-07FD-65E8-4885-36BA868F1106}"/>
              </a:ext>
            </a:extLst>
          </p:cNvPr>
          <p:cNvGrpSpPr/>
          <p:nvPr/>
        </p:nvGrpSpPr>
        <p:grpSpPr>
          <a:xfrm>
            <a:off x="29815" y="3415537"/>
            <a:ext cx="3517568" cy="2724375"/>
            <a:chOff x="29815" y="3415537"/>
            <a:chExt cx="3517568" cy="2724375"/>
          </a:xfrm>
        </p:grpSpPr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08210D3B-5472-9710-9D8F-CDE90EE776F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83867" y="3503839"/>
              <a:ext cx="3044538" cy="2444656"/>
            </a:xfrm>
            <a:prstGeom prst="rect">
              <a:avLst/>
            </a:prstGeom>
          </p:spPr>
        </p:pic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EF472AEE-2BEC-A294-B664-4FA78695C1D5}"/>
                </a:ext>
              </a:extLst>
            </p:cNvPr>
            <p:cNvSpPr/>
            <p:nvPr/>
          </p:nvSpPr>
          <p:spPr>
            <a:xfrm>
              <a:off x="2888879" y="4372881"/>
              <a:ext cx="353506" cy="5925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FDAF78A6-9568-24C3-E03F-B4100592CF1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880599" y="5027950"/>
              <a:ext cx="666784" cy="711237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D016786-CD68-D767-8A89-92A386336A54}"/>
                </a:ext>
              </a:extLst>
            </p:cNvPr>
            <p:cNvSpPr txBox="1"/>
            <p:nvPr/>
          </p:nvSpPr>
          <p:spPr>
            <a:xfrm>
              <a:off x="548885" y="5832135"/>
              <a:ext cx="217117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lvl="0"/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esh                     Frozen                         Frozen</a:t>
              </a:r>
            </a:p>
            <a:p>
              <a:pPr lvl="0"/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              Cells                            Tissue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1DA4385-6227-0317-ED7E-5CCA19C11805}"/>
                </a:ext>
              </a:extLst>
            </p:cNvPr>
            <p:cNvSpPr txBox="1"/>
            <p:nvPr/>
          </p:nvSpPr>
          <p:spPr>
            <a:xfrm rot="16200000">
              <a:off x="-1039667" y="4485019"/>
              <a:ext cx="2431351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lvl="0"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cent of Cells (%)</a:t>
              </a:r>
            </a:p>
            <a:p>
              <a:pPr lvl="0"/>
              <a:r>
                <a:rPr lang="en-US" sz="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          </a:t>
              </a:r>
              <a:r>
                <a:rPr lang="en-US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10                     20                     30                    40                    50              60  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6BDD3CC9-1AED-B3FC-5863-A15EB9664B89}"/>
              </a:ext>
            </a:extLst>
          </p:cNvPr>
          <p:cNvGrpSpPr/>
          <p:nvPr/>
        </p:nvGrpSpPr>
        <p:grpSpPr>
          <a:xfrm>
            <a:off x="6528" y="676660"/>
            <a:ext cx="3656936" cy="2545120"/>
            <a:chOff x="0" y="296538"/>
            <a:chExt cx="3656936" cy="2545120"/>
          </a:xfrm>
        </p:grpSpPr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48F4C732-9BB9-B486-6EBC-42707D707B32}"/>
                </a:ext>
              </a:extLst>
            </p:cNvPr>
            <p:cNvSpPr/>
            <p:nvPr/>
          </p:nvSpPr>
          <p:spPr>
            <a:xfrm>
              <a:off x="229193" y="296538"/>
              <a:ext cx="2963746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OE - Remission</a:t>
              </a:r>
            </a:p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(Fresh, Frozen tissue, Frozen cells)</a:t>
              </a:r>
            </a:p>
          </p:txBody>
        </p:sp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B9F98907-975F-78C4-C7D4-5DE626867A1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8118" y="902350"/>
              <a:ext cx="2404758" cy="1798279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99172C90-A458-A327-5D4F-02D568505F3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485596" y="895288"/>
              <a:ext cx="177809" cy="1409772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721C5789-0AD2-1ECE-C644-64D55ACBDAB8}"/>
                </a:ext>
              </a:extLst>
            </p:cNvPr>
            <p:cNvSpPr txBox="1"/>
            <p:nvPr/>
          </p:nvSpPr>
          <p:spPr>
            <a:xfrm>
              <a:off x="2586459" y="846784"/>
              <a:ext cx="785122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-Diff_low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024B7F1-B02F-4C75-92FE-A249997F0E63}"/>
                </a:ext>
              </a:extLst>
            </p:cNvPr>
            <p:cNvSpPr txBox="1"/>
            <p:nvPr/>
          </p:nvSpPr>
          <p:spPr>
            <a:xfrm>
              <a:off x="2553453" y="997773"/>
              <a:ext cx="869801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1-Diff_high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F239879-DEA7-A235-E381-1BA76C949F66}"/>
                </a:ext>
              </a:extLst>
            </p:cNvPr>
            <p:cNvSpPr txBox="1"/>
            <p:nvPr/>
          </p:nvSpPr>
          <p:spPr>
            <a:xfrm>
              <a:off x="2559923" y="1170826"/>
              <a:ext cx="88998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2-Diff_high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22AF444-22D5-9526-F976-90FA38CA5698}"/>
                </a:ext>
              </a:extLst>
            </p:cNvPr>
            <p:cNvSpPr txBox="1"/>
            <p:nvPr/>
          </p:nvSpPr>
          <p:spPr>
            <a:xfrm>
              <a:off x="2559924" y="1323272"/>
              <a:ext cx="869802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3-Trans1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F655028-0FAA-6B67-B07D-8112D009200A}"/>
                </a:ext>
              </a:extLst>
            </p:cNvPr>
            <p:cNvSpPr txBox="1"/>
            <p:nvPr/>
          </p:nvSpPr>
          <p:spPr>
            <a:xfrm>
              <a:off x="2557420" y="1497743"/>
              <a:ext cx="100951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4-Proliferating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203635B2-50ED-1942-DC5A-BB0CEF3EDFCD}"/>
                </a:ext>
              </a:extLst>
            </p:cNvPr>
            <p:cNvSpPr txBox="1"/>
            <p:nvPr/>
          </p:nvSpPr>
          <p:spPr>
            <a:xfrm>
              <a:off x="2559924" y="1646280"/>
              <a:ext cx="79584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5-Trans2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71FF259D-74E7-C2F7-92A0-D85AC6EB8F22}"/>
                </a:ext>
              </a:extLst>
            </p:cNvPr>
            <p:cNvSpPr txBox="1"/>
            <p:nvPr/>
          </p:nvSpPr>
          <p:spPr>
            <a:xfrm>
              <a:off x="2559923" y="1799721"/>
              <a:ext cx="106582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6-Quiescent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351FA0D-B064-EFB6-5E8F-8C2D5A7F8B7C}"/>
                </a:ext>
              </a:extLst>
            </p:cNvPr>
            <p:cNvSpPr txBox="1"/>
            <p:nvPr/>
          </p:nvSpPr>
          <p:spPr>
            <a:xfrm>
              <a:off x="2591063" y="1964691"/>
              <a:ext cx="106582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-Trans2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267894A-14DE-D799-E143-BCF8E8D13FCD}"/>
                </a:ext>
              </a:extLst>
            </p:cNvPr>
            <p:cNvSpPr txBox="1"/>
            <p:nvPr/>
          </p:nvSpPr>
          <p:spPr>
            <a:xfrm>
              <a:off x="2588030" y="2120013"/>
              <a:ext cx="106890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-Quiescent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5AD1587-0CAF-8D3B-6B39-DB608386392D}"/>
                </a:ext>
              </a:extLst>
            </p:cNvPr>
            <p:cNvSpPr txBox="1"/>
            <p:nvPr/>
          </p:nvSpPr>
          <p:spPr>
            <a:xfrm>
              <a:off x="1028946" y="2595437"/>
              <a:ext cx="104075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lvl="0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MAP1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456C360-B9D1-0093-624A-C081D1045D43}"/>
                </a:ext>
              </a:extLst>
            </p:cNvPr>
            <p:cNvSpPr txBox="1"/>
            <p:nvPr/>
          </p:nvSpPr>
          <p:spPr>
            <a:xfrm rot="16200000">
              <a:off x="-397267" y="1220185"/>
              <a:ext cx="104075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lvl="0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MAP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54882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5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ceves, Seema</dc:creator>
  <cp:lastModifiedBy>Aceves, Seema</cp:lastModifiedBy>
  <cp:revision>1</cp:revision>
  <dcterms:created xsi:type="dcterms:W3CDTF">2026-06-15T01:51:14Z</dcterms:created>
  <dcterms:modified xsi:type="dcterms:W3CDTF">2026-06-15T01:51:37Z</dcterms:modified>
</cp:coreProperties>
</file>